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7700"/>
    <p:restoredTop sz="50000"/>
  </p:normalViewPr>
  <p:slideViewPr>
    <p:cSldViewPr snapToGrid="0" snapToObjects="1">
      <p:cViewPr varScale="1">
        <p:scale>
          <a:sx n="64" d="100"/>
          <a:sy n="64" d="100"/>
        </p:scale>
        <p:origin x="3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stherpearl:Documents:WORK%202:Manuscripts:SpermCryoPaperwithEXRC:SpermCryoData_Raw&amp;Graphs_Pearletal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1 masc v homog'!$A$28</c:f>
              <c:strCache>
                <c:ptCount val="1"/>
                <c:pt idx="0">
                  <c:v>% fertilis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1 masc v homog'!$D$28:$E$28</c:f>
                <c:numCache>
                  <c:formatCode>General</c:formatCode>
                  <c:ptCount val="2"/>
                  <c:pt idx="0">
                    <c:v>2.749140893470789</c:v>
                  </c:pt>
                  <c:pt idx="1">
                    <c:v>6.868699758680449</c:v>
                  </c:pt>
                </c:numCache>
              </c:numRef>
            </c:plus>
            <c:minus>
              <c:numRef>
                <c:f>'Supp 1 masc v homog'!$D$28:$E$28</c:f>
                <c:numCache>
                  <c:formatCode>General</c:formatCode>
                  <c:ptCount val="2"/>
                  <c:pt idx="0">
                    <c:v>2.749140893470789</c:v>
                  </c:pt>
                  <c:pt idx="1">
                    <c:v>6.868699758680449</c:v>
                  </c:pt>
                </c:numCache>
              </c:numRef>
            </c:minus>
          </c:errBars>
          <c:cat>
            <c:strRef>
              <c:f>'Supp 1 masc v homog'!$B$27:$C$27</c:f>
              <c:strCache>
                <c:ptCount val="2"/>
                <c:pt idx="0">
                  <c:v>Homogenised</c:v>
                </c:pt>
                <c:pt idx="1">
                  <c:v>Mascerated</c:v>
                </c:pt>
              </c:strCache>
            </c:strRef>
          </c:cat>
          <c:val>
            <c:numRef>
              <c:f>'Supp 1 masc v homog'!$B$28:$C$28</c:f>
              <c:numCache>
                <c:formatCode>0.00</c:formatCode>
                <c:ptCount val="2"/>
                <c:pt idx="0">
                  <c:v>97.25085910652894</c:v>
                </c:pt>
                <c:pt idx="1">
                  <c:v>92.11601307189542</c:v>
                </c:pt>
              </c:numCache>
            </c:numRef>
          </c:val>
        </c:ser>
        <c:ser>
          <c:idx val="1"/>
          <c:order val="1"/>
          <c:tx>
            <c:strRef>
              <c:f>'Supp 1 masc v homog'!$A$29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1 masc v homog'!$D$29:$E$29</c:f>
                <c:numCache>
                  <c:formatCode>General</c:formatCode>
                  <c:ptCount val="2"/>
                  <c:pt idx="0">
                    <c:v>3.358744804767022</c:v>
                  </c:pt>
                  <c:pt idx="1">
                    <c:v>3.467974923288634</c:v>
                  </c:pt>
                </c:numCache>
              </c:numRef>
            </c:plus>
            <c:minus>
              <c:numRef>
                <c:f>'Supp 1 masc v homog'!$D$29:$E$29</c:f>
                <c:numCache>
                  <c:formatCode>General</c:formatCode>
                  <c:ptCount val="2"/>
                  <c:pt idx="0">
                    <c:v>3.358744804767022</c:v>
                  </c:pt>
                  <c:pt idx="1">
                    <c:v>3.467974923288634</c:v>
                  </c:pt>
                </c:numCache>
              </c:numRef>
            </c:minus>
          </c:errBars>
          <c:cat>
            <c:strRef>
              <c:f>'Supp 1 masc v homog'!$B$27:$C$27</c:f>
              <c:strCache>
                <c:ptCount val="2"/>
                <c:pt idx="0">
                  <c:v>Homogenised</c:v>
                </c:pt>
                <c:pt idx="1">
                  <c:v>Mascerated</c:v>
                </c:pt>
              </c:strCache>
            </c:strRef>
          </c:cat>
          <c:val>
            <c:numRef>
              <c:f>'Supp 1 masc v homog'!$B$29:$C$29</c:f>
              <c:numCache>
                <c:formatCode>General</c:formatCode>
                <c:ptCount val="2"/>
                <c:pt idx="0">
                  <c:v>70.65387016229693</c:v>
                </c:pt>
                <c:pt idx="1">
                  <c:v>68.43835242771411</c:v>
                </c:pt>
              </c:numCache>
            </c:numRef>
          </c:val>
        </c:ser>
        <c:ser>
          <c:idx val="2"/>
          <c:order val="2"/>
          <c:tx>
            <c:strRef>
              <c:f>'Supp 1 masc v homog'!$A$30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1 masc v homog'!$D$30:$E$30</c:f>
                <c:numCache>
                  <c:formatCode>General</c:formatCode>
                  <c:ptCount val="2"/>
                  <c:pt idx="0">
                    <c:v>8.54276684054322</c:v>
                  </c:pt>
                  <c:pt idx="1">
                    <c:v>6.125019324091729</c:v>
                  </c:pt>
                </c:numCache>
              </c:numRef>
            </c:plus>
            <c:minus>
              <c:numRef>
                <c:f>'Supp 1 masc v homog'!$D$30:$E$30</c:f>
                <c:numCache>
                  <c:formatCode>General</c:formatCode>
                  <c:ptCount val="2"/>
                  <c:pt idx="0">
                    <c:v>8.54276684054322</c:v>
                  </c:pt>
                  <c:pt idx="1">
                    <c:v>6.125019324091729</c:v>
                  </c:pt>
                </c:numCache>
              </c:numRef>
            </c:minus>
          </c:errBars>
          <c:cat>
            <c:strRef>
              <c:f>'Supp 1 masc v homog'!$B$27:$C$27</c:f>
              <c:strCache>
                <c:ptCount val="2"/>
                <c:pt idx="0">
                  <c:v>Homogenised</c:v>
                </c:pt>
                <c:pt idx="1">
                  <c:v>Mascerated</c:v>
                </c:pt>
              </c:strCache>
            </c:strRef>
          </c:cat>
          <c:val>
            <c:numRef>
              <c:f>'Supp 1 masc v homog'!$B$30:$C$30</c:f>
              <c:numCache>
                <c:formatCode>General</c:formatCode>
                <c:ptCount val="2"/>
                <c:pt idx="0">
                  <c:v>27.98245614035088</c:v>
                </c:pt>
                <c:pt idx="1">
                  <c:v>35.029164522216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3853088"/>
        <c:axId val="-2116517408"/>
      </c:barChart>
      <c:catAx>
        <c:axId val="-2123853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16517408"/>
        <c:crosses val="autoZero"/>
        <c:auto val="1"/>
        <c:lblAlgn val="ctr"/>
        <c:lblOffset val="100"/>
        <c:noMultiLvlLbl val="0"/>
      </c:catAx>
      <c:valAx>
        <c:axId val="-2116517408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-2123853088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2 4vs8'!$Q$7</c:f>
              <c:strCache>
                <c:ptCount val="1"/>
                <c:pt idx="0">
                  <c:v>% fertilis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2 4vs8'!$T$7:$U$7</c:f>
                <c:numCache>
                  <c:formatCode>General</c:formatCode>
                  <c:ptCount val="2"/>
                  <c:pt idx="0">
                    <c:v>4.64745054572289</c:v>
                  </c:pt>
                  <c:pt idx="1">
                    <c:v>11.48855206221153</c:v>
                  </c:pt>
                </c:numCache>
              </c:numRef>
            </c:plus>
            <c:minus>
              <c:numRef>
                <c:f>'Supp 2 4vs8'!$T$7:$U$7</c:f>
                <c:numCache>
                  <c:formatCode>General</c:formatCode>
                  <c:ptCount val="2"/>
                  <c:pt idx="0">
                    <c:v>4.64745054572289</c:v>
                  </c:pt>
                  <c:pt idx="1">
                    <c:v>11.48855206221153</c:v>
                  </c:pt>
                </c:numCache>
              </c:numRef>
            </c:minus>
          </c:errBars>
          <c:cat>
            <c:strRef>
              <c:f>'Supp 2 4vs8'!$R$6:$S$6</c:f>
              <c:strCache>
                <c:ptCount val="2"/>
                <c:pt idx="0">
                  <c:v>4 tubes</c:v>
                </c:pt>
                <c:pt idx="1">
                  <c:v>8 tubes</c:v>
                </c:pt>
              </c:strCache>
            </c:strRef>
          </c:cat>
          <c:val>
            <c:numRef>
              <c:f>'Supp 2 4vs8'!$R$7:$S$7</c:f>
              <c:numCache>
                <c:formatCode>General</c:formatCode>
                <c:ptCount val="2"/>
                <c:pt idx="0">
                  <c:v>90.16149516890007</c:v>
                </c:pt>
                <c:pt idx="1">
                  <c:v>66.14567694487355</c:v>
                </c:pt>
              </c:numCache>
            </c:numRef>
          </c:val>
        </c:ser>
        <c:ser>
          <c:idx val="1"/>
          <c:order val="1"/>
          <c:tx>
            <c:strRef>
              <c:f>'Supp 2 4vs8'!$Q$8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2 4vs8'!$T$8:$U$8</c:f>
                <c:numCache>
                  <c:formatCode>General</c:formatCode>
                  <c:ptCount val="2"/>
                  <c:pt idx="0">
                    <c:v>7.104297207683508</c:v>
                  </c:pt>
                  <c:pt idx="1">
                    <c:v>2.460497106821764</c:v>
                  </c:pt>
                </c:numCache>
              </c:numRef>
            </c:plus>
            <c:minus>
              <c:numRef>
                <c:f>'Supp 2 4vs8'!$T$8:$U$8</c:f>
                <c:numCache>
                  <c:formatCode>General</c:formatCode>
                  <c:ptCount val="2"/>
                  <c:pt idx="0">
                    <c:v>7.104297207683508</c:v>
                  </c:pt>
                  <c:pt idx="1">
                    <c:v>2.460497106821764</c:v>
                  </c:pt>
                </c:numCache>
              </c:numRef>
            </c:minus>
          </c:errBars>
          <c:cat>
            <c:strRef>
              <c:f>'Supp 2 4vs8'!$R$6:$S$6</c:f>
              <c:strCache>
                <c:ptCount val="2"/>
                <c:pt idx="0">
                  <c:v>4 tubes</c:v>
                </c:pt>
                <c:pt idx="1">
                  <c:v>8 tubes</c:v>
                </c:pt>
              </c:strCache>
            </c:strRef>
          </c:cat>
          <c:val>
            <c:numRef>
              <c:f>'Supp 2 4vs8'!$R$8:$S$8</c:f>
              <c:numCache>
                <c:formatCode>General</c:formatCode>
                <c:ptCount val="2"/>
                <c:pt idx="0">
                  <c:v>88.7385404613929</c:v>
                </c:pt>
                <c:pt idx="1">
                  <c:v>90.53321109848152</c:v>
                </c:pt>
              </c:numCache>
            </c:numRef>
          </c:val>
        </c:ser>
        <c:ser>
          <c:idx val="2"/>
          <c:order val="2"/>
          <c:tx>
            <c:strRef>
              <c:f>'Supp 2 4vs8'!$Q$9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2 4vs8'!$T$9:$U$9</c:f>
                <c:numCache>
                  <c:formatCode>General</c:formatCode>
                  <c:ptCount val="2"/>
                  <c:pt idx="0">
                    <c:v>0.750792678288408</c:v>
                  </c:pt>
                  <c:pt idx="1">
                    <c:v>0.619576815402573</c:v>
                  </c:pt>
                </c:numCache>
              </c:numRef>
            </c:plus>
            <c:minus>
              <c:numRef>
                <c:f>'Supp 2 4vs8'!$T$9:$U$9</c:f>
                <c:numCache>
                  <c:formatCode>General</c:formatCode>
                  <c:ptCount val="2"/>
                  <c:pt idx="0">
                    <c:v>0.750792678288408</c:v>
                  </c:pt>
                  <c:pt idx="1">
                    <c:v>0.619576815402573</c:v>
                  </c:pt>
                </c:numCache>
              </c:numRef>
            </c:minus>
          </c:errBars>
          <c:cat>
            <c:strRef>
              <c:f>'Supp 2 4vs8'!$R$6:$S$6</c:f>
              <c:strCache>
                <c:ptCount val="2"/>
                <c:pt idx="0">
                  <c:v>4 tubes</c:v>
                </c:pt>
                <c:pt idx="1">
                  <c:v>8 tubes</c:v>
                </c:pt>
              </c:strCache>
            </c:strRef>
          </c:cat>
          <c:val>
            <c:numRef>
              <c:f>'Supp 2 4vs8'!$R$9:$S$9</c:f>
              <c:numCache>
                <c:formatCode>General</c:formatCode>
                <c:ptCount val="2"/>
                <c:pt idx="0">
                  <c:v>98.498802985495</c:v>
                </c:pt>
                <c:pt idx="1">
                  <c:v>95.797822853467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3889712"/>
        <c:axId val="-2115532320"/>
      </c:barChart>
      <c:catAx>
        <c:axId val="-20838897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15532320"/>
        <c:crosses val="autoZero"/>
        <c:auto val="1"/>
        <c:lblAlgn val="ctr"/>
        <c:lblOffset val="100"/>
        <c:noMultiLvlLbl val="0"/>
      </c:catAx>
      <c:valAx>
        <c:axId val="-2115532320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</a:t>
                </a:r>
                <a:r>
                  <a:rPr lang="en-US" baseline="0"/>
                  <a:t> fertilisation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-208388971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3 delays'!$AA$17</c:f>
              <c:strCache>
                <c:ptCount val="1"/>
                <c:pt idx="0">
                  <c:v>% fertilis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AB$7:$AF$7</c:f>
                <c:numCache>
                  <c:formatCode>General</c:formatCode>
                  <c:ptCount val="5"/>
                  <c:pt idx="0">
                    <c:v>6.27596733391287</c:v>
                  </c:pt>
                  <c:pt idx="1">
                    <c:v>8.36668070262059</c:v>
                  </c:pt>
                  <c:pt idx="2">
                    <c:v>9.033574503800427</c:v>
                  </c:pt>
                  <c:pt idx="3">
                    <c:v>11.80053596695358</c:v>
                  </c:pt>
                  <c:pt idx="4">
                    <c:v>12.96371145661207</c:v>
                  </c:pt>
                </c:numCache>
              </c:numRef>
            </c:plus>
            <c:minus>
              <c:numRef>
                <c:f>'Supp 3 delays'!$AB$7:$AF$7</c:f>
                <c:numCache>
                  <c:formatCode>General</c:formatCode>
                  <c:ptCount val="5"/>
                  <c:pt idx="0">
                    <c:v>6.27596733391287</c:v>
                  </c:pt>
                  <c:pt idx="1">
                    <c:v>8.36668070262059</c:v>
                  </c:pt>
                  <c:pt idx="2">
                    <c:v>9.033574503800427</c:v>
                  </c:pt>
                  <c:pt idx="3">
                    <c:v>11.80053596695358</c:v>
                  </c:pt>
                  <c:pt idx="4">
                    <c:v>12.96371145661207</c:v>
                  </c:pt>
                </c:numCache>
              </c:numRef>
            </c:minus>
          </c:errBars>
          <c:cat>
            <c:strRef>
              <c:f>'Supp 3 delays'!$AB$16:$AF$1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AB$17:$AF$17</c:f>
              <c:numCache>
                <c:formatCode>General</c:formatCode>
                <c:ptCount val="5"/>
                <c:pt idx="0">
                  <c:v>91.96003839339932</c:v>
                </c:pt>
                <c:pt idx="1">
                  <c:v>72.14632075419611</c:v>
                </c:pt>
                <c:pt idx="2">
                  <c:v>61.13463566888537</c:v>
                </c:pt>
                <c:pt idx="3">
                  <c:v>53.99145705813977</c:v>
                </c:pt>
                <c:pt idx="4">
                  <c:v>50.83801599373167</c:v>
                </c:pt>
              </c:numCache>
            </c:numRef>
          </c:val>
        </c:ser>
        <c:ser>
          <c:idx val="1"/>
          <c:order val="1"/>
          <c:tx>
            <c:strRef>
              <c:f>'Supp 3 delays'!$AA$18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AB$8:$AF$8</c:f>
                <c:numCache>
                  <c:formatCode>General</c:formatCode>
                  <c:ptCount val="5"/>
                  <c:pt idx="0">
                    <c:v>13.89903066768195</c:v>
                  </c:pt>
                  <c:pt idx="1">
                    <c:v>12.60717418736016</c:v>
                  </c:pt>
                  <c:pt idx="2">
                    <c:v>11.99703347550943</c:v>
                  </c:pt>
                  <c:pt idx="3">
                    <c:v>15.32934815623225</c:v>
                  </c:pt>
                  <c:pt idx="4">
                    <c:v>12.13068370486271</c:v>
                  </c:pt>
                </c:numCache>
              </c:numRef>
            </c:plus>
            <c:minus>
              <c:numRef>
                <c:f>'Supp 3 delays'!$AB$8:$AF$8</c:f>
                <c:numCache>
                  <c:formatCode>General</c:formatCode>
                  <c:ptCount val="5"/>
                  <c:pt idx="0">
                    <c:v>13.89903066768195</c:v>
                  </c:pt>
                  <c:pt idx="1">
                    <c:v>12.60717418736016</c:v>
                  </c:pt>
                  <c:pt idx="2">
                    <c:v>11.99703347550943</c:v>
                  </c:pt>
                  <c:pt idx="3">
                    <c:v>15.32934815623225</c:v>
                  </c:pt>
                  <c:pt idx="4">
                    <c:v>12.13068370486271</c:v>
                  </c:pt>
                </c:numCache>
              </c:numRef>
            </c:minus>
          </c:errBars>
          <c:cat>
            <c:strRef>
              <c:f>'Supp 3 delays'!$AB$16:$AF$1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AB$18:$AF$18</c:f>
              <c:numCache>
                <c:formatCode>General</c:formatCode>
                <c:ptCount val="5"/>
                <c:pt idx="0">
                  <c:v>58.68464880641717</c:v>
                </c:pt>
                <c:pt idx="1">
                  <c:v>63.78155075411235</c:v>
                </c:pt>
                <c:pt idx="2">
                  <c:v>57.03659024241842</c:v>
                </c:pt>
                <c:pt idx="3">
                  <c:v>50.72842489121555</c:v>
                </c:pt>
                <c:pt idx="4">
                  <c:v>56.38931185034809</c:v>
                </c:pt>
              </c:numCache>
            </c:numRef>
          </c:val>
        </c:ser>
        <c:ser>
          <c:idx val="2"/>
          <c:order val="2"/>
          <c:tx>
            <c:strRef>
              <c:f>'Supp 3 delays'!$AA$19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AB$9:$AF$9</c:f>
                <c:numCache>
                  <c:formatCode>General</c:formatCode>
                  <c:ptCount val="5"/>
                  <c:pt idx="0">
                    <c:v>4.384258804612497</c:v>
                  </c:pt>
                  <c:pt idx="1">
                    <c:v>5.24081002001283</c:v>
                  </c:pt>
                  <c:pt idx="2">
                    <c:v>6.643237780580474</c:v>
                  </c:pt>
                  <c:pt idx="3">
                    <c:v>13.14153338301943</c:v>
                  </c:pt>
                  <c:pt idx="4">
                    <c:v>3.366828154464557</c:v>
                  </c:pt>
                </c:numCache>
              </c:numRef>
            </c:plus>
            <c:minus>
              <c:numRef>
                <c:f>'Supp 3 delays'!$AB$9:$AF$9</c:f>
                <c:numCache>
                  <c:formatCode>General</c:formatCode>
                  <c:ptCount val="5"/>
                  <c:pt idx="0">
                    <c:v>4.384258804612497</c:v>
                  </c:pt>
                  <c:pt idx="1">
                    <c:v>5.24081002001283</c:v>
                  </c:pt>
                  <c:pt idx="2">
                    <c:v>6.643237780580474</c:v>
                  </c:pt>
                  <c:pt idx="3">
                    <c:v>13.14153338301943</c:v>
                  </c:pt>
                  <c:pt idx="4">
                    <c:v>3.366828154464557</c:v>
                  </c:pt>
                </c:numCache>
              </c:numRef>
            </c:minus>
          </c:errBars>
          <c:cat>
            <c:strRef>
              <c:f>'Supp 3 delays'!$AB$16:$AF$1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AB$19:$AF$19</c:f>
              <c:numCache>
                <c:formatCode>General</c:formatCode>
                <c:ptCount val="5"/>
                <c:pt idx="0">
                  <c:v>85.15590540523261</c:v>
                </c:pt>
                <c:pt idx="1">
                  <c:v>77.25310205947571</c:v>
                </c:pt>
                <c:pt idx="2">
                  <c:v>82.81516810664976</c:v>
                </c:pt>
                <c:pt idx="3">
                  <c:v>73.39501775080335</c:v>
                </c:pt>
                <c:pt idx="4">
                  <c:v>93.190092065970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0055296"/>
        <c:axId val="-2118800752"/>
      </c:barChart>
      <c:catAx>
        <c:axId val="-2060055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18800752"/>
        <c:crosses val="autoZero"/>
        <c:auto val="1"/>
        <c:lblAlgn val="ctr"/>
        <c:lblOffset val="100"/>
        <c:noMultiLvlLbl val="0"/>
      </c:catAx>
      <c:valAx>
        <c:axId val="-2118800752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-2060055296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3 delays'!$L$7</c:f>
              <c:strCache>
                <c:ptCount val="1"/>
                <c:pt idx="0">
                  <c:v>% fertilis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W$7:$AA$7</c:f>
                <c:numCache>
                  <c:formatCode>General</c:formatCode>
                  <c:ptCount val="5"/>
                  <c:pt idx="0">
                    <c:v>1.060918492201796</c:v>
                  </c:pt>
                  <c:pt idx="1">
                    <c:v>7.48222998250092</c:v>
                  </c:pt>
                  <c:pt idx="2">
                    <c:v>3.815615553259517</c:v>
                  </c:pt>
                  <c:pt idx="3">
                    <c:v>5.38821374071817</c:v>
                  </c:pt>
                  <c:pt idx="4">
                    <c:v>3.765522253138867</c:v>
                  </c:pt>
                </c:numCache>
              </c:numRef>
            </c:plus>
            <c:minus>
              <c:numRef>
                <c:f>'Supp 3 delays'!$W$7:$AA$7</c:f>
                <c:numCache>
                  <c:formatCode>General</c:formatCode>
                  <c:ptCount val="5"/>
                  <c:pt idx="0">
                    <c:v>1.060918492201796</c:v>
                  </c:pt>
                  <c:pt idx="1">
                    <c:v>7.48222998250092</c:v>
                  </c:pt>
                  <c:pt idx="2">
                    <c:v>3.815615553259517</c:v>
                  </c:pt>
                  <c:pt idx="3">
                    <c:v>5.38821374071817</c:v>
                  </c:pt>
                  <c:pt idx="4">
                    <c:v>3.765522253138867</c:v>
                  </c:pt>
                </c:numCache>
              </c:numRef>
            </c:minus>
          </c:errBars>
          <c:cat>
            <c:strRef>
              <c:f>'Supp 3 delays'!$M$6:$Q$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M$7:$Q$7</c:f>
              <c:numCache>
                <c:formatCode>0.00</c:formatCode>
                <c:ptCount val="5"/>
                <c:pt idx="0">
                  <c:v>98.4906185665199</c:v>
                </c:pt>
                <c:pt idx="1">
                  <c:v>82.61518850132143</c:v>
                </c:pt>
                <c:pt idx="2">
                  <c:v>80.72637874839299</c:v>
                </c:pt>
                <c:pt idx="3">
                  <c:v>84.40300471008238</c:v>
                </c:pt>
                <c:pt idx="4">
                  <c:v>86.61847380809529</c:v>
                </c:pt>
              </c:numCache>
            </c:numRef>
          </c:val>
        </c:ser>
        <c:ser>
          <c:idx val="1"/>
          <c:order val="1"/>
          <c:tx>
            <c:strRef>
              <c:f>'Supp 3 delays'!$L$8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W$8:$AA$8</c:f>
                <c:numCache>
                  <c:formatCode>General</c:formatCode>
                  <c:ptCount val="5"/>
                  <c:pt idx="0">
                    <c:v>16.75468281083267</c:v>
                  </c:pt>
                  <c:pt idx="1">
                    <c:v>12.3854036870972</c:v>
                  </c:pt>
                  <c:pt idx="2">
                    <c:v>14.4732747727939</c:v>
                  </c:pt>
                  <c:pt idx="3">
                    <c:v>14.59922786081194</c:v>
                  </c:pt>
                  <c:pt idx="4">
                    <c:v>16.84560520260388</c:v>
                  </c:pt>
                </c:numCache>
              </c:numRef>
            </c:plus>
            <c:minus>
              <c:numRef>
                <c:f>'Supp 3 delays'!$W$8:$AA$8</c:f>
                <c:numCache>
                  <c:formatCode>General</c:formatCode>
                  <c:ptCount val="5"/>
                  <c:pt idx="0">
                    <c:v>16.75468281083267</c:v>
                  </c:pt>
                  <c:pt idx="1">
                    <c:v>12.3854036870972</c:v>
                  </c:pt>
                  <c:pt idx="2">
                    <c:v>14.4732747727939</c:v>
                  </c:pt>
                  <c:pt idx="3">
                    <c:v>14.59922786081194</c:v>
                  </c:pt>
                  <c:pt idx="4">
                    <c:v>16.84560520260388</c:v>
                  </c:pt>
                </c:numCache>
              </c:numRef>
            </c:minus>
          </c:errBars>
          <c:cat>
            <c:strRef>
              <c:f>'Supp 3 delays'!$M$6:$Q$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M$8:$Q$8</c:f>
              <c:numCache>
                <c:formatCode>0.00</c:formatCode>
                <c:ptCount val="5"/>
                <c:pt idx="0">
                  <c:v>57.900879004382</c:v>
                </c:pt>
                <c:pt idx="1">
                  <c:v>60.74746739952207</c:v>
                </c:pt>
                <c:pt idx="2">
                  <c:v>60.08220083217436</c:v>
                </c:pt>
                <c:pt idx="3">
                  <c:v>49.1222550805807</c:v>
                </c:pt>
                <c:pt idx="4">
                  <c:v>55.79624563812136</c:v>
                </c:pt>
              </c:numCache>
            </c:numRef>
          </c:val>
        </c:ser>
        <c:ser>
          <c:idx val="2"/>
          <c:order val="2"/>
          <c:tx>
            <c:strRef>
              <c:f>'Supp 3 delays'!$L$9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3 delays'!$W$9:$AA$9</c:f>
                <c:numCache>
                  <c:formatCode>General</c:formatCode>
                  <c:ptCount val="5"/>
                  <c:pt idx="0">
                    <c:v>6.120860562437797</c:v>
                  </c:pt>
                  <c:pt idx="1">
                    <c:v>4.34746792359849</c:v>
                  </c:pt>
                  <c:pt idx="2">
                    <c:v>2.813323688927941</c:v>
                  </c:pt>
                  <c:pt idx="3">
                    <c:v>6.658145007226436</c:v>
                  </c:pt>
                  <c:pt idx="4">
                    <c:v>2.44998432973903</c:v>
                  </c:pt>
                </c:numCache>
              </c:numRef>
            </c:plus>
            <c:minus>
              <c:numRef>
                <c:f>'Supp 3 delays'!$W$9:$AA$9</c:f>
                <c:numCache>
                  <c:formatCode>General</c:formatCode>
                  <c:ptCount val="5"/>
                  <c:pt idx="0">
                    <c:v>6.120860562437797</c:v>
                  </c:pt>
                  <c:pt idx="1">
                    <c:v>4.34746792359849</c:v>
                  </c:pt>
                  <c:pt idx="2">
                    <c:v>2.813323688927941</c:v>
                  </c:pt>
                  <c:pt idx="3">
                    <c:v>6.658145007226436</c:v>
                  </c:pt>
                  <c:pt idx="4">
                    <c:v>2.44998432973903</c:v>
                  </c:pt>
                </c:numCache>
              </c:numRef>
            </c:minus>
          </c:errBars>
          <c:cat>
            <c:strRef>
              <c:f>'Supp 3 delays'!$M$6:$Q$6</c:f>
              <c:strCache>
                <c:ptCount val="5"/>
                <c:pt idx="0">
                  <c:v>fresh</c:v>
                </c:pt>
                <c:pt idx="1">
                  <c:v>0' </c:v>
                </c:pt>
                <c:pt idx="2">
                  <c:v>5'</c:v>
                </c:pt>
                <c:pt idx="3">
                  <c:v>10'</c:v>
                </c:pt>
                <c:pt idx="4">
                  <c:v>20'</c:v>
                </c:pt>
              </c:strCache>
            </c:strRef>
          </c:cat>
          <c:val>
            <c:numRef>
              <c:f>'Supp 3 delays'!$M$9:$Q$9</c:f>
              <c:numCache>
                <c:formatCode>0.00</c:formatCode>
                <c:ptCount val="5"/>
                <c:pt idx="0">
                  <c:v>88.3611633272261</c:v>
                </c:pt>
                <c:pt idx="1">
                  <c:v>88.35346695316345</c:v>
                </c:pt>
                <c:pt idx="2">
                  <c:v>92.80529651299715</c:v>
                </c:pt>
                <c:pt idx="3">
                  <c:v>88.05065132042249</c:v>
                </c:pt>
                <c:pt idx="4">
                  <c:v>95.806894994156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4497824"/>
        <c:axId val="-2088607984"/>
      </c:barChart>
      <c:catAx>
        <c:axId val="-2084497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088607984"/>
        <c:crosses val="autoZero"/>
        <c:auto val="1"/>
        <c:lblAlgn val="ctr"/>
        <c:lblOffset val="100"/>
        <c:noMultiLvlLbl val="0"/>
      </c:catAx>
      <c:valAx>
        <c:axId val="-2088607984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-2084497824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4 delays no freezing'!$L$9</c:f>
              <c:strCache>
                <c:ptCount val="1"/>
                <c:pt idx="0">
                  <c:v>% fertiliz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9:$T$9</c:f>
                <c:numCache>
                  <c:formatCode>General</c:formatCode>
                  <c:ptCount val="4"/>
                  <c:pt idx="0">
                    <c:v>2.260925943718217</c:v>
                  </c:pt>
                  <c:pt idx="1">
                    <c:v>2.308332180648474</c:v>
                  </c:pt>
                  <c:pt idx="2">
                    <c:v>0.713139354664669</c:v>
                  </c:pt>
                  <c:pt idx="3">
                    <c:v>0.644152478449415</c:v>
                  </c:pt>
                </c:numCache>
              </c:numRef>
            </c:plus>
            <c:minus>
              <c:numRef>
                <c:f>'Supp 4 delays no freezing'!$Q$9:$T$9</c:f>
                <c:numCache>
                  <c:formatCode>General</c:formatCode>
                  <c:ptCount val="4"/>
                  <c:pt idx="0">
                    <c:v>2.260925943718217</c:v>
                  </c:pt>
                  <c:pt idx="1">
                    <c:v>2.308332180648474</c:v>
                  </c:pt>
                  <c:pt idx="2">
                    <c:v>0.713139354664669</c:v>
                  </c:pt>
                  <c:pt idx="3">
                    <c:v>0.644152478449415</c:v>
                  </c:pt>
                </c:numCache>
              </c:numRef>
            </c:minus>
          </c:errBars>
          <c:cat>
            <c:strRef>
              <c:f>'Supp 4 delays no freezing'!$M$8:$P$8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9:$P$9</c:f>
              <c:numCache>
                <c:formatCode>0.00</c:formatCode>
                <c:ptCount val="4"/>
                <c:pt idx="0">
                  <c:v>96.83068195831792</c:v>
                </c:pt>
                <c:pt idx="1">
                  <c:v>94.63877201184322</c:v>
                </c:pt>
                <c:pt idx="2" formatCode="General">
                  <c:v>62.0</c:v>
                </c:pt>
                <c:pt idx="3">
                  <c:v>98.62363620494021</c:v>
                </c:pt>
              </c:numCache>
            </c:numRef>
          </c:val>
        </c:ser>
        <c:ser>
          <c:idx val="1"/>
          <c:order val="1"/>
          <c:tx>
            <c:strRef>
              <c:f>'Supp 4 delays no freezing'!$L$10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10:$T$10</c:f>
                <c:numCache>
                  <c:formatCode>General</c:formatCode>
                  <c:ptCount val="4"/>
                  <c:pt idx="0">
                    <c:v>5.550019917841317</c:v>
                  </c:pt>
                  <c:pt idx="1">
                    <c:v>11.16601219801606</c:v>
                  </c:pt>
                  <c:pt idx="2">
                    <c:v>11.8496514719794</c:v>
                  </c:pt>
                  <c:pt idx="3">
                    <c:v>14.10614161448338</c:v>
                  </c:pt>
                </c:numCache>
              </c:numRef>
            </c:plus>
            <c:minus>
              <c:numRef>
                <c:f>'Supp 4 delays no freezing'!$Q$10:$T$10</c:f>
                <c:numCache>
                  <c:formatCode>General</c:formatCode>
                  <c:ptCount val="4"/>
                  <c:pt idx="0">
                    <c:v>5.550019917841317</c:v>
                  </c:pt>
                  <c:pt idx="1">
                    <c:v>11.16601219801606</c:v>
                  </c:pt>
                  <c:pt idx="2">
                    <c:v>11.8496514719794</c:v>
                  </c:pt>
                  <c:pt idx="3">
                    <c:v>14.10614161448338</c:v>
                  </c:pt>
                </c:numCache>
              </c:numRef>
            </c:minus>
          </c:errBars>
          <c:cat>
            <c:strRef>
              <c:f>'Supp 4 delays no freezing'!$M$8:$P$8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10:$P$10</c:f>
              <c:numCache>
                <c:formatCode>0.00</c:formatCode>
                <c:ptCount val="4"/>
                <c:pt idx="0">
                  <c:v>46.57142857142847</c:v>
                </c:pt>
                <c:pt idx="1">
                  <c:v>37.67917346984817</c:v>
                </c:pt>
                <c:pt idx="2">
                  <c:v>58.29491591658253</c:v>
                </c:pt>
                <c:pt idx="3">
                  <c:v>36.7363727363728</c:v>
                </c:pt>
              </c:numCache>
            </c:numRef>
          </c:val>
        </c:ser>
        <c:ser>
          <c:idx val="2"/>
          <c:order val="2"/>
          <c:tx>
            <c:strRef>
              <c:f>'Supp 4 delays no freezing'!$L$11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11:$T$11</c:f>
                <c:numCache>
                  <c:formatCode>General</c:formatCode>
                  <c:ptCount val="4"/>
                  <c:pt idx="0">
                    <c:v>3.801063503843759</c:v>
                  </c:pt>
                  <c:pt idx="1">
                    <c:v>8.252158604604195</c:v>
                  </c:pt>
                  <c:pt idx="2">
                    <c:v>1.197474353749687</c:v>
                  </c:pt>
                  <c:pt idx="3">
                    <c:v>5.120241594489301</c:v>
                  </c:pt>
                </c:numCache>
              </c:numRef>
            </c:plus>
            <c:minus>
              <c:numRef>
                <c:f>'Supp 4 delays no freezing'!$Q$11:$T$11</c:f>
                <c:numCache>
                  <c:formatCode>General</c:formatCode>
                  <c:ptCount val="4"/>
                  <c:pt idx="0">
                    <c:v>3.801063503843759</c:v>
                  </c:pt>
                  <c:pt idx="1">
                    <c:v>8.252158604604195</c:v>
                  </c:pt>
                  <c:pt idx="2">
                    <c:v>1.197474353749687</c:v>
                  </c:pt>
                  <c:pt idx="3">
                    <c:v>5.120241594489301</c:v>
                  </c:pt>
                </c:numCache>
              </c:numRef>
            </c:minus>
          </c:errBars>
          <c:cat>
            <c:strRef>
              <c:f>'Supp 4 delays no freezing'!$M$8:$P$8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11:$P$11</c:f>
              <c:numCache>
                <c:formatCode>0.00</c:formatCode>
                <c:ptCount val="4"/>
                <c:pt idx="0">
                  <c:v>87.24867724867726</c:v>
                </c:pt>
                <c:pt idx="1">
                  <c:v>78.30513784461127</c:v>
                </c:pt>
                <c:pt idx="2">
                  <c:v>89.5642895642896</c:v>
                </c:pt>
                <c:pt idx="3">
                  <c:v>85.23255813953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5660624"/>
        <c:axId val="-2058755088"/>
      </c:barChart>
      <c:catAx>
        <c:axId val="-212566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058755088"/>
        <c:crosses val="autoZero"/>
        <c:auto val="1"/>
        <c:lblAlgn val="ctr"/>
        <c:lblOffset val="100"/>
        <c:noMultiLvlLbl val="0"/>
      </c:catAx>
      <c:valAx>
        <c:axId val="-2058755088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-2125660624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 4 delays no freezing'!$L$36</c:f>
              <c:strCache>
                <c:ptCount val="1"/>
                <c:pt idx="0">
                  <c:v>% fertiliz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36:$T$36</c:f>
                <c:numCache>
                  <c:formatCode>General</c:formatCode>
                  <c:ptCount val="4"/>
                  <c:pt idx="0">
                    <c:v>0.327647636023365</c:v>
                  </c:pt>
                  <c:pt idx="1">
                    <c:v>1.573377841666605</c:v>
                  </c:pt>
                  <c:pt idx="2">
                    <c:v>3.064828286982776</c:v>
                  </c:pt>
                  <c:pt idx="3">
                    <c:v>2.345079523750138</c:v>
                  </c:pt>
                </c:numCache>
              </c:numRef>
            </c:plus>
            <c:minus>
              <c:numRef>
                <c:f>'Supp 4 delays no freezing'!$Q$36:$T$36</c:f>
                <c:numCache>
                  <c:formatCode>General</c:formatCode>
                  <c:ptCount val="4"/>
                  <c:pt idx="0">
                    <c:v>0.327647636023365</c:v>
                  </c:pt>
                  <c:pt idx="1">
                    <c:v>1.573377841666605</c:v>
                  </c:pt>
                  <c:pt idx="2">
                    <c:v>3.064828286982776</c:v>
                  </c:pt>
                  <c:pt idx="3">
                    <c:v>2.345079523750138</c:v>
                  </c:pt>
                </c:numCache>
              </c:numRef>
            </c:minus>
          </c:errBars>
          <c:cat>
            <c:strRef>
              <c:f>'Supp 4 delays no freezing'!$M$35:$P$35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36:$P$36</c:f>
              <c:numCache>
                <c:formatCode>0.00</c:formatCode>
                <c:ptCount val="4"/>
                <c:pt idx="0">
                  <c:v>99.36219906575638</c:v>
                </c:pt>
                <c:pt idx="1">
                  <c:v>96.49259259259243</c:v>
                </c:pt>
                <c:pt idx="2">
                  <c:v>93.31797965177196</c:v>
                </c:pt>
                <c:pt idx="3">
                  <c:v>97.3601723969044</c:v>
                </c:pt>
              </c:numCache>
            </c:numRef>
          </c:val>
        </c:ser>
        <c:ser>
          <c:idx val="1"/>
          <c:order val="1"/>
          <c:tx>
            <c:strRef>
              <c:f>'Supp 4 delays no freezing'!$L$37</c:f>
              <c:strCache>
                <c:ptCount val="1"/>
                <c:pt idx="0">
                  <c:v>% survival to NF3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37:$T$37</c:f>
                <c:numCache>
                  <c:formatCode>General</c:formatCode>
                  <c:ptCount val="4"/>
                  <c:pt idx="0">
                    <c:v>16.99961795049683</c:v>
                  </c:pt>
                  <c:pt idx="1">
                    <c:v>20.60206060648722</c:v>
                  </c:pt>
                  <c:pt idx="2">
                    <c:v>14.58691235412557</c:v>
                  </c:pt>
                  <c:pt idx="3">
                    <c:v>16.84688671358529</c:v>
                  </c:pt>
                </c:numCache>
              </c:numRef>
            </c:plus>
            <c:minus>
              <c:numRef>
                <c:f>'Supp 4 delays no freezing'!$Q$37:$T$37</c:f>
                <c:numCache>
                  <c:formatCode>General</c:formatCode>
                  <c:ptCount val="4"/>
                  <c:pt idx="0">
                    <c:v>16.99961795049683</c:v>
                  </c:pt>
                  <c:pt idx="1">
                    <c:v>20.60206060648722</c:v>
                  </c:pt>
                  <c:pt idx="2">
                    <c:v>14.58691235412557</c:v>
                  </c:pt>
                  <c:pt idx="3">
                    <c:v>16.84688671358529</c:v>
                  </c:pt>
                </c:numCache>
              </c:numRef>
            </c:minus>
          </c:errBars>
          <c:cat>
            <c:strRef>
              <c:f>'Supp 4 delays no freezing'!$M$35:$P$35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37:$P$37</c:f>
              <c:numCache>
                <c:formatCode>0.00</c:formatCode>
                <c:ptCount val="4"/>
                <c:pt idx="0">
                  <c:v>61.17015098722415</c:v>
                </c:pt>
                <c:pt idx="1">
                  <c:v>63.41971584023104</c:v>
                </c:pt>
                <c:pt idx="2">
                  <c:v>61.3170687383581</c:v>
                </c:pt>
                <c:pt idx="3">
                  <c:v>67.546034507757</c:v>
                </c:pt>
              </c:numCache>
            </c:numRef>
          </c:val>
        </c:ser>
        <c:ser>
          <c:idx val="2"/>
          <c:order val="2"/>
          <c:tx>
            <c:strRef>
              <c:f>'Supp 4 delays no freezing'!$L$38</c:f>
              <c:strCache>
                <c:ptCount val="1"/>
                <c:pt idx="0">
                  <c:v>% normal at NF3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upp 4 delays no freezing'!$Q$38:$T$38</c:f>
                <c:numCache>
                  <c:formatCode>General</c:formatCode>
                  <c:ptCount val="4"/>
                  <c:pt idx="0">
                    <c:v>6.33667936856469</c:v>
                  </c:pt>
                  <c:pt idx="1">
                    <c:v>3.127628463571269</c:v>
                  </c:pt>
                  <c:pt idx="2">
                    <c:v>1.697250257391051</c:v>
                  </c:pt>
                  <c:pt idx="3">
                    <c:v>3.206631364999473</c:v>
                  </c:pt>
                </c:numCache>
              </c:numRef>
            </c:plus>
            <c:minus>
              <c:numRef>
                <c:f>'Supp 4 delays no freezing'!$Q$38:$T$38</c:f>
                <c:numCache>
                  <c:formatCode>General</c:formatCode>
                  <c:ptCount val="4"/>
                  <c:pt idx="0">
                    <c:v>6.33667936856469</c:v>
                  </c:pt>
                  <c:pt idx="1">
                    <c:v>3.127628463571269</c:v>
                  </c:pt>
                  <c:pt idx="2">
                    <c:v>1.697250257391051</c:v>
                  </c:pt>
                  <c:pt idx="3">
                    <c:v>3.206631364999473</c:v>
                  </c:pt>
                </c:numCache>
              </c:numRef>
            </c:minus>
          </c:errBars>
          <c:cat>
            <c:strRef>
              <c:f>'Supp 4 delays no freezing'!$M$35:$P$35</c:f>
              <c:strCache>
                <c:ptCount val="4"/>
                <c:pt idx="0">
                  <c:v>0' </c:v>
                </c:pt>
                <c:pt idx="1">
                  <c:v>5'</c:v>
                </c:pt>
                <c:pt idx="2">
                  <c:v>10'</c:v>
                </c:pt>
                <c:pt idx="3">
                  <c:v>20'</c:v>
                </c:pt>
              </c:strCache>
            </c:strRef>
          </c:cat>
          <c:val>
            <c:numRef>
              <c:f>'Supp 4 delays no freezing'!$M$38:$P$38</c:f>
              <c:numCache>
                <c:formatCode>0.00</c:formatCode>
                <c:ptCount val="4"/>
                <c:pt idx="0">
                  <c:v>76.1617537231472</c:v>
                </c:pt>
                <c:pt idx="1">
                  <c:v>84.10968849402875</c:v>
                </c:pt>
                <c:pt idx="2">
                  <c:v>81.11111111111111</c:v>
                </c:pt>
                <c:pt idx="3">
                  <c:v>81.0038012641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59154480"/>
        <c:axId val="-2126016400"/>
      </c:barChart>
      <c:catAx>
        <c:axId val="-2059154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126016400"/>
        <c:crosses val="autoZero"/>
        <c:auto val="1"/>
        <c:lblAlgn val="ctr"/>
        <c:lblOffset val="100"/>
        <c:noMultiLvlLbl val="0"/>
      </c:catAx>
      <c:valAx>
        <c:axId val="-2126016400"/>
        <c:scaling>
          <c:orientation val="minMax"/>
          <c:max val="10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-2059154480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3362D-9354-324D-864C-4FFB8B6955B3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58CE38-FAF3-8B44-8817-70C7CD6D1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970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EF7FF7-E302-BD43-8EB3-FE0F0A81404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8438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11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1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316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144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249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676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6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347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034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87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16439-8D4E-8945-8AE8-E4D80EA10360}" type="datetimeFigureOut">
              <a:rPr lang="en-US" smtClean="0"/>
              <a:t>10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50BDB-1910-5347-95EB-F74ADA3EC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537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3.xml"/><Relationship Id="rId3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5.xml"/><Relationship Id="rId3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266700" y="2298339"/>
          <a:ext cx="6337300" cy="821027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84325"/>
                <a:gridCol w="1584325"/>
                <a:gridCol w="1584325"/>
                <a:gridCol w="1584325"/>
              </a:tblGrid>
              <a:tr h="34329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Protocols:</a:t>
                      </a:r>
                      <a:endParaRPr lang="en-GB" sz="1200" b="1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</a:rPr>
                        <a:t>Mansour</a:t>
                      </a:r>
                      <a:endParaRPr lang="en-GB" sz="1200" b="1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</a:rPr>
                        <a:t>Harland</a:t>
                      </a:r>
                      <a:endParaRPr lang="en-GB" sz="1200" b="1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</a:rPr>
                        <a:t>Sargent</a:t>
                      </a:r>
                      <a:endParaRPr lang="en-GB" sz="1200" b="1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9387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err="1" smtClean="0">
                          <a:effectLst/>
                        </a:rPr>
                        <a:t>Cryoprotectant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S (motility inhibiting saline):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50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>
                          <a:effectLst/>
                        </a:rPr>
                        <a:t>NaCl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3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>
                          <a:effectLst/>
                        </a:rPr>
                        <a:t>KCl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MgSO</a:t>
                      </a:r>
                      <a:r>
                        <a:rPr lang="en-GB" sz="1200" baseline="-25000" dirty="0">
                          <a:effectLst/>
                        </a:rPr>
                        <a:t>4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mM CaCl</a:t>
                      </a:r>
                      <a:r>
                        <a:rPr lang="en-GB" sz="1200" baseline="-25000" dirty="0">
                          <a:effectLst/>
                        </a:rPr>
                        <a:t>2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0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>
                          <a:effectLst/>
                        </a:rPr>
                        <a:t>Tris</a:t>
                      </a:r>
                      <a:r>
                        <a:rPr lang="en-GB" sz="1200" dirty="0">
                          <a:effectLst/>
                        </a:rPr>
                        <a:t> pH8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5 % DMSO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73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sucros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(stored at RT)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 0.4 M sucros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0mM NaHCO</a:t>
                      </a:r>
                      <a:r>
                        <a:rPr lang="en-GB" sz="1200" baseline="-25000">
                          <a:effectLst/>
                        </a:rPr>
                        <a:t>3</a:t>
                      </a:r>
                      <a:endParaRPr lang="en-GB" sz="120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 mM pentoxifyllin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ixed 4:1 with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:1 egg yolk:water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(aliquoted and stored at -20C, thawed on ice on day of use)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8 M sucros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0.02 M NaHCO</a:t>
                      </a:r>
                      <a:r>
                        <a:rPr lang="en-GB" sz="1200" baseline="-25000" dirty="0">
                          <a:effectLst/>
                        </a:rPr>
                        <a:t>3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>
                          <a:effectLst/>
                        </a:rPr>
                        <a:t>pentoxifylline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xed 4:1 with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:1 egg </a:t>
                      </a:r>
                      <a:r>
                        <a:rPr lang="en-GB" sz="1200" dirty="0" err="1">
                          <a:effectLst/>
                        </a:rPr>
                        <a:t>yolk:water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(</a:t>
                      </a:r>
                      <a:r>
                        <a:rPr lang="en-GB" sz="1200" dirty="0" err="1">
                          <a:effectLst/>
                        </a:rPr>
                        <a:t>aliquoted</a:t>
                      </a:r>
                      <a:r>
                        <a:rPr lang="en-GB" sz="1200" dirty="0">
                          <a:effectLst/>
                        </a:rPr>
                        <a:t> and stored at </a:t>
                      </a:r>
                      <a:r>
                        <a:rPr lang="en-GB" sz="1200" dirty="0" smtClean="0">
                          <a:effectLst/>
                        </a:rPr>
                        <a:t>-20C</a:t>
                      </a:r>
                      <a:r>
                        <a:rPr lang="en-GB" sz="1200" dirty="0">
                          <a:effectLst/>
                        </a:rPr>
                        <a:t>, thawed on ice on day of use)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9558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Solution to macerate testes </a:t>
                      </a:r>
                      <a:r>
                        <a:rPr lang="en-GB" sz="1200" dirty="0" smtClean="0">
                          <a:effectLst/>
                        </a:rPr>
                        <a:t>in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500</a:t>
                      </a:r>
                      <a:r>
                        <a:rPr lang="en-GB" sz="1200" dirty="0">
                          <a:effectLst/>
                        </a:rPr>
                        <a:t> </a:t>
                      </a:r>
                      <a:r>
                        <a:rPr lang="en-GB" sz="1200" dirty="0" err="1">
                          <a:effectLst/>
                        </a:rPr>
                        <a:t>uL</a:t>
                      </a:r>
                      <a:r>
                        <a:rPr lang="en-GB" sz="1200" dirty="0">
                          <a:effectLst/>
                        </a:rPr>
                        <a:t> MIS </a:t>
                      </a:r>
                      <a:r>
                        <a:rPr lang="en-GB" sz="1200" dirty="0" smtClean="0">
                          <a:effectLst/>
                        </a:rPr>
                        <a:t>solution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en-GB" sz="1200" dirty="0" smtClean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Ice-col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500</a:t>
                      </a:r>
                      <a:r>
                        <a:rPr lang="en-GB" sz="1200" dirty="0">
                          <a:effectLst/>
                        </a:rPr>
                        <a:t> </a:t>
                      </a:r>
                      <a:r>
                        <a:rPr lang="en-GB" sz="1200" dirty="0" err="1">
                          <a:effectLst/>
                        </a:rPr>
                        <a:t>uL</a:t>
                      </a:r>
                      <a:r>
                        <a:rPr lang="en-GB" sz="1200" dirty="0">
                          <a:effectLst/>
                        </a:rPr>
                        <a:t> L-15 with: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0 % FBS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L-</a:t>
                      </a:r>
                      <a:r>
                        <a:rPr lang="en-GB" sz="1200" dirty="0" smtClean="0">
                          <a:effectLst/>
                        </a:rPr>
                        <a:t>glutamin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en-GB" sz="1200" dirty="0" smtClean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Ice-cold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(make L-15/glutamine/FBS mix fresh on day of use, store aliquots of FBS and L-glutamine at -20C)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500</a:t>
                      </a:r>
                      <a:r>
                        <a:rPr lang="en-GB" sz="1200" dirty="0">
                          <a:effectLst/>
                        </a:rPr>
                        <a:t> </a:t>
                      </a:r>
                      <a:r>
                        <a:rPr lang="en-GB" sz="1200" dirty="0" err="1">
                          <a:effectLst/>
                        </a:rPr>
                        <a:t>uL</a:t>
                      </a:r>
                      <a:r>
                        <a:rPr lang="en-GB" sz="1200" dirty="0">
                          <a:effectLst/>
                        </a:rPr>
                        <a:t> L-15 with: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2 </a:t>
                      </a:r>
                      <a:r>
                        <a:rPr lang="en-GB" sz="1200" dirty="0" err="1">
                          <a:effectLst/>
                        </a:rPr>
                        <a:t>mM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 smtClean="0">
                          <a:effectLst/>
                        </a:rPr>
                        <a:t>glutaMAX</a:t>
                      </a:r>
                      <a:endParaRPr lang="en-GB" sz="1200" dirty="0" smtClean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endParaRPr lang="en-GB" sz="1200" dirty="0" smtClean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effectLst/>
                        </a:rPr>
                        <a:t>Ice-cold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(make L-15/</a:t>
                      </a:r>
                      <a:r>
                        <a:rPr lang="en-GB" sz="1200" dirty="0" err="1">
                          <a:effectLst/>
                        </a:rPr>
                        <a:t>glutaMAX</a:t>
                      </a:r>
                      <a:r>
                        <a:rPr lang="en-GB" sz="1200" dirty="0">
                          <a:effectLst/>
                        </a:rPr>
                        <a:t> mix fresh on day of use)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15247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Action after testes </a:t>
                      </a:r>
                      <a:r>
                        <a:rPr lang="en-GB" sz="1200" dirty="0" smtClean="0">
                          <a:effectLst/>
                        </a:rPr>
                        <a:t>macerated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Aliquot for freezing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ix with equal volume ice-cold cryoprotectant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Aliquot for freezing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x with equal volume ice-cold </a:t>
                      </a:r>
                      <a:r>
                        <a:rPr lang="en-GB" sz="1200" dirty="0" err="1">
                          <a:effectLst/>
                        </a:rPr>
                        <a:t>cryoprotectant</a:t>
                      </a:r>
                      <a:endParaRPr lang="en-GB" sz="12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Aliquot for freezing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55259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Freezing Method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ut tubes in a rack suspended 10 cm above the surface of liquid nitrogen for 7 mins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ut tubes in a rack in a room temperature Styrofoam box, put the box in -80C for 24 hours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Put tubes in a rack in a box containing </a:t>
                      </a:r>
                      <a:r>
                        <a:rPr lang="en-GB" sz="1200" dirty="0" err="1">
                          <a:effectLst/>
                        </a:rPr>
                        <a:t>EtOH</a:t>
                      </a:r>
                      <a:r>
                        <a:rPr lang="en-GB" sz="1200" dirty="0">
                          <a:effectLst/>
                        </a:rPr>
                        <a:t> with a stir bar, put that box in a larger box containing dry ice and </a:t>
                      </a:r>
                      <a:r>
                        <a:rPr lang="en-GB" sz="1200" dirty="0" err="1">
                          <a:effectLst/>
                        </a:rPr>
                        <a:t>EtOH</a:t>
                      </a:r>
                      <a:r>
                        <a:rPr lang="en-GB" sz="1200" dirty="0">
                          <a:effectLst/>
                        </a:rPr>
                        <a:t> on a magnetic stir plate for 10mins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50865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Thawing method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40 sec at RT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30 sec at RT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0 sec in 30 degree </a:t>
                      </a:r>
                      <a:r>
                        <a:rPr lang="en-GB" sz="1200" dirty="0" err="1">
                          <a:effectLst/>
                        </a:rPr>
                        <a:t>waterbath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6477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Activation method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Dilute 1:1 with 0.1 X MMR, put on eggs immediately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Dilute 1:1 with 0.1 X MMR, put on eggs immediately</a:t>
                      </a:r>
                      <a:endParaRPr lang="en-GB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Dilute 1:1 with 0.1 X MMR, put on eggs immediately</a:t>
                      </a:r>
                      <a:endParaRPr lang="en-GB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0584" y="1652008"/>
            <a:ext cx="67474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Table 1: Comparison of the sperm cryopreservation protocols of Mansour, Harland and Sargen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9636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684" y="5267960"/>
            <a:ext cx="60616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: There is no difference in sperm viability between sperm </a:t>
            </a:r>
            <a:r>
              <a:rPr lang="en-US" sz="1200" b="1" dirty="0" err="1"/>
              <a:t>homogenised</a:t>
            </a:r>
            <a:r>
              <a:rPr lang="en-US" sz="1200" b="1" dirty="0"/>
              <a:t> using a pestle and sperm </a:t>
            </a:r>
            <a:r>
              <a:rPr lang="en-US" sz="1200" b="1" dirty="0" err="1"/>
              <a:t>mascerated</a:t>
            </a:r>
            <a:r>
              <a:rPr lang="en-US" sz="1200" b="1" dirty="0"/>
              <a:t> using forceps. </a:t>
            </a:r>
            <a:r>
              <a:rPr lang="en-US" sz="1200" dirty="0"/>
              <a:t>Sperm was either </a:t>
            </a:r>
            <a:r>
              <a:rPr lang="en-US" sz="1200" dirty="0" err="1"/>
              <a:t>homogenised</a:t>
            </a:r>
            <a:r>
              <a:rPr lang="en-US" sz="1200" dirty="0"/>
              <a:t> with a pestle or </a:t>
            </a:r>
            <a:r>
              <a:rPr lang="en-US" sz="1200" dirty="0" err="1"/>
              <a:t>mascerated</a:t>
            </a:r>
            <a:r>
              <a:rPr lang="en-US" sz="1200" dirty="0"/>
              <a:t> with forceps.  Sperm was then </a:t>
            </a:r>
            <a:r>
              <a:rPr lang="en-US" sz="1200" dirty="0"/>
              <a:t>frozen by </a:t>
            </a:r>
            <a:r>
              <a:rPr lang="en-US" sz="1200" dirty="0"/>
              <a:t>the Harland method </a:t>
            </a:r>
            <a:r>
              <a:rPr lang="en-US" sz="1200" dirty="0"/>
              <a:t>and stored </a:t>
            </a:r>
            <a:r>
              <a:rPr lang="en-US" sz="1200" dirty="0"/>
              <a:t>in -80 for 2 days, after which it was used to </a:t>
            </a:r>
            <a:r>
              <a:rPr lang="en-US" sz="1200" dirty="0" err="1"/>
              <a:t>fertilise</a:t>
            </a:r>
            <a:r>
              <a:rPr lang="en-US" sz="1200" dirty="0"/>
              <a:t> eggs.  Means </a:t>
            </a:r>
            <a:r>
              <a:rPr lang="en-US" sz="1200" dirty="0"/>
              <a:t>+/- SEM are shown. </a:t>
            </a:r>
            <a:r>
              <a:rPr lang="en-GB" sz="1200" dirty="0"/>
              <a:t>The </a:t>
            </a:r>
            <a:r>
              <a:rPr lang="en-GB" sz="1200" dirty="0"/>
              <a:t>technique doesn’t have an effect on the fertility (</a:t>
            </a:r>
            <a:r>
              <a:rPr lang="en-GB" sz="1200" i="1" dirty="0"/>
              <a:t>p</a:t>
            </a:r>
            <a:r>
              <a:rPr lang="en-GB" sz="1200" dirty="0"/>
              <a:t> = 0.86</a:t>
            </a:r>
            <a:r>
              <a:rPr lang="en-GB" sz="1200" dirty="0"/>
              <a:t>), or </a:t>
            </a:r>
            <a:r>
              <a:rPr lang="en-GB" sz="1200" dirty="0"/>
              <a:t>an effect on </a:t>
            </a:r>
            <a:r>
              <a:rPr lang="en-GB" sz="1200" dirty="0"/>
              <a:t>the percentage of normal</a:t>
            </a:r>
            <a:r>
              <a:rPr lang="en-GB" sz="1200" dirty="0"/>
              <a:t> </a:t>
            </a:r>
            <a:r>
              <a:rPr lang="en-GB" sz="1200" dirty="0"/>
              <a:t>tadpoles </a:t>
            </a:r>
            <a:r>
              <a:rPr lang="en-GB" sz="1200" dirty="0"/>
              <a:t>(</a:t>
            </a:r>
            <a:r>
              <a:rPr lang="en-GB" sz="1200" i="1" dirty="0"/>
              <a:t>p</a:t>
            </a:r>
            <a:r>
              <a:rPr lang="en-GB" sz="1200" dirty="0"/>
              <a:t> = 0.34).</a:t>
            </a:r>
            <a:r>
              <a:rPr lang="en-US" sz="1200" dirty="0"/>
              <a:t> </a:t>
            </a:r>
            <a:endParaRPr lang="en-US" sz="1200" dirty="0"/>
          </a:p>
          <a:p>
            <a:endParaRPr lang="en-US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1003300" y="23241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799163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2684" y="5763261"/>
            <a:ext cx="60616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2</a:t>
            </a:r>
            <a:r>
              <a:rPr lang="en-US" sz="1200" b="1" dirty="0"/>
              <a:t>.</a:t>
            </a:r>
            <a:r>
              <a:rPr lang="en-US" sz="1200" b="1" dirty="0"/>
              <a:t> Dividing each testis into 4 tubes </a:t>
            </a:r>
            <a:r>
              <a:rPr lang="en-US" sz="1200" b="1" dirty="0" err="1"/>
              <a:t>vs</a:t>
            </a:r>
            <a:r>
              <a:rPr lang="en-US" sz="1200" b="1" dirty="0"/>
              <a:t> 8 tubes has little difference on sperm viability . </a:t>
            </a:r>
            <a:r>
              <a:rPr lang="en-US" sz="1200" dirty="0"/>
              <a:t>Eggs were </a:t>
            </a:r>
            <a:r>
              <a:rPr lang="en-US" sz="1200" dirty="0" err="1"/>
              <a:t>fertilised</a:t>
            </a:r>
            <a:r>
              <a:rPr lang="en-US" sz="1200" dirty="0"/>
              <a:t> with sperm cryopreserved </a:t>
            </a:r>
            <a:r>
              <a:rPr lang="en-US" sz="1200" dirty="0"/>
              <a:t>by </a:t>
            </a:r>
            <a:r>
              <a:rPr lang="en-US" sz="1200" dirty="0"/>
              <a:t>the Harland method, with each testis either divided into 4 tubes or 8 tubes, </a:t>
            </a:r>
            <a:r>
              <a:rPr lang="en-US" sz="1200" dirty="0"/>
              <a:t>and stored </a:t>
            </a:r>
            <a:r>
              <a:rPr lang="en-US" sz="1200" dirty="0"/>
              <a:t>in liquid nitrogen for 13 months.  Means </a:t>
            </a:r>
            <a:r>
              <a:rPr lang="en-US" sz="1200" dirty="0"/>
              <a:t>+/- SEM are shown. </a:t>
            </a:r>
            <a:r>
              <a:rPr lang="en-GB" sz="1200" dirty="0"/>
              <a:t>There is no effect of the division of the sperm in 4 or 8 tubes on the sperm viability (</a:t>
            </a:r>
            <a:r>
              <a:rPr lang="en-GB" sz="1200" i="1" dirty="0"/>
              <a:t>p</a:t>
            </a:r>
            <a:r>
              <a:rPr lang="en-GB" sz="1200" dirty="0"/>
              <a:t> = 0.12). </a:t>
            </a:r>
            <a:endParaRPr lang="en-US" sz="1200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1143000" y="27305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777513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4684" y="178935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4685" y="5279456"/>
            <a:ext cx="268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2684" y="8773161"/>
            <a:ext cx="60616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3. Delaying the freezing of sperm, or the application of thawed sperm to eggs has little difference on sperm viability . </a:t>
            </a:r>
            <a:r>
              <a:rPr lang="en-US" sz="1200" dirty="0"/>
              <a:t>Eggs were </a:t>
            </a:r>
            <a:r>
              <a:rPr lang="en-US" sz="1200" dirty="0" err="1"/>
              <a:t>fertilised</a:t>
            </a:r>
            <a:r>
              <a:rPr lang="en-US" sz="1200" dirty="0"/>
              <a:t> with sperm cryopreserved </a:t>
            </a:r>
            <a:r>
              <a:rPr lang="en-US" sz="1200" dirty="0"/>
              <a:t>by </a:t>
            </a:r>
            <a:r>
              <a:rPr lang="en-US" sz="1200" dirty="0"/>
              <a:t>the Harland method, with delays either (A) prior to the sperm going into the -80 for 2 days, or (B) delays after the frozen sperm was thawed after 2 days in the -80.  Means </a:t>
            </a:r>
            <a:r>
              <a:rPr lang="en-US" sz="1200" dirty="0"/>
              <a:t>+/- SEM are shown. </a:t>
            </a:r>
            <a:r>
              <a:rPr lang="en-GB" sz="1200" dirty="0"/>
              <a:t>There </a:t>
            </a:r>
            <a:r>
              <a:rPr lang="en-GB" sz="1200" dirty="0"/>
              <a:t>is </a:t>
            </a:r>
            <a:r>
              <a:rPr lang="en-GB" sz="1200" dirty="0"/>
              <a:t>no effect of the </a:t>
            </a:r>
            <a:r>
              <a:rPr lang="en-GB" sz="1200" dirty="0" err="1"/>
              <a:t>masceration</a:t>
            </a:r>
            <a:r>
              <a:rPr lang="en-GB" sz="1200" dirty="0"/>
              <a:t> delay (</a:t>
            </a:r>
            <a:r>
              <a:rPr lang="en-GB" sz="1200" i="1" dirty="0"/>
              <a:t>p</a:t>
            </a:r>
            <a:r>
              <a:rPr lang="en-GB" sz="1200" dirty="0"/>
              <a:t> = 0.18) </a:t>
            </a:r>
            <a:r>
              <a:rPr lang="en-GB" sz="1200" dirty="0"/>
              <a:t>on the fertilisation percentage.</a:t>
            </a:r>
            <a:r>
              <a:rPr lang="en-US" sz="1200" dirty="0"/>
              <a:t> </a:t>
            </a: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549120" y="5279456"/>
          <a:ext cx="5800881" cy="3381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/>
          </p:nvPr>
        </p:nvGraphicFramePr>
        <p:xfrm>
          <a:off x="372536" y="1876912"/>
          <a:ext cx="6091765" cy="330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2634713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4684" y="178935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74685" y="4860356"/>
            <a:ext cx="268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2684" y="8773160"/>
            <a:ext cx="606161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4. Delaying. </a:t>
            </a:r>
            <a:r>
              <a:rPr lang="en-US" sz="1200" dirty="0"/>
              <a:t>Eggs were </a:t>
            </a:r>
            <a:r>
              <a:rPr lang="en-US" sz="1200" dirty="0" err="1"/>
              <a:t>fertilised</a:t>
            </a:r>
            <a:r>
              <a:rPr lang="en-US" sz="1200" dirty="0"/>
              <a:t> with fresh sperm that had been </a:t>
            </a:r>
            <a:r>
              <a:rPr lang="en-US" sz="1200" dirty="0" err="1"/>
              <a:t>mascerated</a:t>
            </a:r>
            <a:r>
              <a:rPr lang="en-US" sz="1200" dirty="0"/>
              <a:t> and incubated at room temperature for the indicated times in either 1 X MBS (A) or 0.1 X MBS (B).  Means </a:t>
            </a:r>
            <a:r>
              <a:rPr lang="en-US" sz="1200" dirty="0"/>
              <a:t>+/- SEM are shown. </a:t>
            </a:r>
            <a:r>
              <a:rPr lang="en-GB" sz="1200" dirty="0"/>
              <a:t>There </a:t>
            </a:r>
            <a:r>
              <a:rPr lang="en-GB" sz="1200" dirty="0"/>
              <a:t>is no </a:t>
            </a:r>
            <a:r>
              <a:rPr lang="en-GB" sz="1200" dirty="0"/>
              <a:t>effect </a:t>
            </a:r>
            <a:r>
              <a:rPr lang="en-GB" sz="1200" dirty="0"/>
              <a:t>of </a:t>
            </a:r>
            <a:r>
              <a:rPr lang="en-GB" sz="1200" dirty="0"/>
              <a:t>the MMR concentration (</a:t>
            </a:r>
            <a:r>
              <a:rPr lang="en-GB" sz="1200" i="1" dirty="0"/>
              <a:t>p</a:t>
            </a:r>
            <a:r>
              <a:rPr lang="en-GB" sz="1200" dirty="0"/>
              <a:t> = 0.88) on </a:t>
            </a:r>
            <a:r>
              <a:rPr lang="en-GB" sz="1200" dirty="0"/>
              <a:t>the fertilisation percentage.</a:t>
            </a:r>
            <a:r>
              <a:rPr lang="en-US" sz="1200" dirty="0"/>
              <a:t> </a:t>
            </a:r>
          </a:p>
          <a:p>
            <a:endParaRPr lang="en-US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549118" y="19812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/>
          </p:nvPr>
        </p:nvGraphicFramePr>
        <p:xfrm>
          <a:off x="543057" y="5137354"/>
          <a:ext cx="4438650" cy="2971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232478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94</Words>
  <Application>Microsoft Macintosh PowerPoint</Application>
  <PresentationFormat>Widescreen</PresentationFormat>
  <Paragraphs>8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Calibri</vt:lpstr>
      <vt:lpstr>Calibri Light</vt:lpstr>
      <vt:lpstr>Cambria</vt:lpstr>
      <vt:lpstr>ＭＳ 明朝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6-10-26T14:23:48Z</dcterms:created>
  <dcterms:modified xsi:type="dcterms:W3CDTF">2016-10-26T14:26:08Z</dcterms:modified>
</cp:coreProperties>
</file>